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  <p:sldId id="258" r:id="rId6"/>
    <p:sldId id="259" r:id="rId7"/>
    <p:sldId id="260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319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7342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651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222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135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941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664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314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252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993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799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98E418-A898-4C8A-891B-9A4BB4E04352}" type="datetimeFigureOut">
              <a:rPr lang="en-US" smtClean="0"/>
              <a:t>1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5DB65D-AA57-43E7-B4A1-CE67E50EBC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722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13" Type="http://schemas.openxmlformats.org/officeDocument/2006/relationships/image" Target="../media/image23.emf"/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12" Type="http://schemas.openxmlformats.org/officeDocument/2006/relationships/image" Target="../media/image22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11" Type="http://schemas.openxmlformats.org/officeDocument/2006/relationships/image" Target="../media/image21.emf"/><Relationship Id="rId5" Type="http://schemas.openxmlformats.org/officeDocument/2006/relationships/image" Target="../media/image15.emf"/><Relationship Id="rId15" Type="http://schemas.openxmlformats.org/officeDocument/2006/relationships/image" Target="../media/image25.emf"/><Relationship Id="rId10" Type="http://schemas.openxmlformats.org/officeDocument/2006/relationships/image" Target="../media/image20.emf"/><Relationship Id="rId4" Type="http://schemas.openxmlformats.org/officeDocument/2006/relationships/image" Target="../media/image14.emf"/><Relationship Id="rId9" Type="http://schemas.openxmlformats.org/officeDocument/2006/relationships/image" Target="../media/image19.emf"/><Relationship Id="rId14" Type="http://schemas.openxmlformats.org/officeDocument/2006/relationships/image" Target="../media/image24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878" y="1064029"/>
            <a:ext cx="7976626" cy="541474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6297943" y="3289853"/>
            <a:ext cx="198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471427" y="2425945"/>
            <a:ext cx="2749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8888819" y="754912"/>
            <a:ext cx="255780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 A plot of 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agF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milarity for all validated primary hits (979 compounds).  Chemical similarity was calculated using the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Warrior</a:t>
            </a:r>
            <a:r>
              <a:rPr lang="en-US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f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oftware package.  The two largest clusters are indicated by the letters A and B and their structures and dose-response curves can be found in Figures S2 and S3.  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61295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8168" y="1212112"/>
            <a:ext cx="5181763" cy="306047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2" name="Group 21"/>
          <p:cNvGrpSpPr/>
          <p:nvPr/>
        </p:nvGrpSpPr>
        <p:grpSpPr>
          <a:xfrm>
            <a:off x="6512323" y="686074"/>
            <a:ext cx="4138260" cy="5219536"/>
            <a:chOff x="6278721" y="588070"/>
            <a:chExt cx="4638024" cy="6131337"/>
          </a:xfrm>
        </p:grpSpPr>
        <p:grpSp>
          <p:nvGrpSpPr>
            <p:cNvPr id="2" name="Group 1"/>
            <p:cNvGrpSpPr/>
            <p:nvPr/>
          </p:nvGrpSpPr>
          <p:grpSpPr>
            <a:xfrm>
              <a:off x="6278721" y="737055"/>
              <a:ext cx="1795413" cy="1251131"/>
              <a:chOff x="6278721" y="737055"/>
              <a:chExt cx="1795413" cy="1251131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78721" y="737055"/>
                <a:ext cx="1795413" cy="910208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6" name="Rectangle 5"/>
              <p:cNvSpPr/>
              <p:nvPr/>
            </p:nvSpPr>
            <p:spPr>
              <a:xfrm>
                <a:off x="6389524" y="1662798"/>
                <a:ext cx="1215804" cy="325388"/>
              </a:xfrm>
              <a:prstGeom prst="rect">
                <a:avLst/>
              </a:prstGeom>
              <a:ln>
                <a:noFill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038441</a:t>
                </a:r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6336774" y="1955838"/>
              <a:ext cx="1737360" cy="1271049"/>
              <a:chOff x="6336774" y="1955838"/>
              <a:chExt cx="1737360" cy="1271049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36774" y="1955838"/>
                <a:ext cx="1737360" cy="880776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9" name="Rectangle 8"/>
              <p:cNvSpPr/>
              <p:nvPr/>
            </p:nvSpPr>
            <p:spPr>
              <a:xfrm>
                <a:off x="6542311" y="2901499"/>
                <a:ext cx="1215804" cy="325388"/>
              </a:xfrm>
              <a:prstGeom prst="rect">
                <a:avLst/>
              </a:prstGeom>
              <a:ln>
                <a:noFill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038858</a:t>
                </a: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6307747" y="3178498"/>
              <a:ext cx="1737360" cy="1285763"/>
              <a:chOff x="6307747" y="3178498"/>
              <a:chExt cx="1737360" cy="1285763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07747" y="3178498"/>
                <a:ext cx="1737360" cy="927928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2" name="Rectangle 11"/>
              <p:cNvSpPr/>
              <p:nvPr/>
            </p:nvSpPr>
            <p:spPr>
              <a:xfrm>
                <a:off x="6542310" y="4138873"/>
                <a:ext cx="1215804" cy="325388"/>
              </a:xfrm>
              <a:prstGeom prst="rect">
                <a:avLst/>
              </a:prstGeom>
              <a:ln>
                <a:noFill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039113</a:t>
                </a:r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6389523" y="4415872"/>
              <a:ext cx="1737360" cy="1132224"/>
              <a:chOff x="6389523" y="4415872"/>
              <a:chExt cx="1737360" cy="1132224"/>
            </a:xfrm>
          </p:grpSpPr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89523" y="4415872"/>
                <a:ext cx="1737360" cy="814874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5" name="Rectangle 14"/>
              <p:cNvSpPr/>
              <p:nvPr/>
            </p:nvSpPr>
            <p:spPr>
              <a:xfrm>
                <a:off x="6693727" y="5222708"/>
                <a:ext cx="1215804" cy="325388"/>
              </a:xfrm>
              <a:prstGeom prst="rect">
                <a:avLst/>
              </a:prstGeom>
              <a:ln>
                <a:noFill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038222</a:t>
                </a: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8705974" y="588070"/>
              <a:ext cx="1737360" cy="1261616"/>
              <a:chOff x="8632496" y="711035"/>
              <a:chExt cx="1737360" cy="1261616"/>
            </a:xfrm>
          </p:grpSpPr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632496" y="711035"/>
                <a:ext cx="1737360" cy="936228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8" name="Rectangle 17"/>
              <p:cNvSpPr/>
              <p:nvPr/>
            </p:nvSpPr>
            <p:spPr>
              <a:xfrm>
                <a:off x="8838577" y="1647263"/>
                <a:ext cx="1215804" cy="325388"/>
              </a:xfrm>
              <a:prstGeom prst="rect">
                <a:avLst/>
              </a:prstGeom>
              <a:ln>
                <a:noFill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038593</a:t>
                </a: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8705974" y="1810657"/>
              <a:ext cx="1737360" cy="1351345"/>
              <a:chOff x="8705974" y="1810657"/>
              <a:chExt cx="1737360" cy="1351345"/>
            </a:xfrm>
          </p:grpSpPr>
          <p:pic>
            <p:nvPicPr>
              <p:cNvPr id="20" name="Picture 19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05974" y="1810657"/>
                <a:ext cx="1737360" cy="880900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21" name="Rectangle 20"/>
              <p:cNvSpPr/>
              <p:nvPr/>
            </p:nvSpPr>
            <p:spPr>
              <a:xfrm>
                <a:off x="8912055" y="2836614"/>
                <a:ext cx="1215804" cy="325388"/>
              </a:xfrm>
              <a:prstGeom prst="rect">
                <a:avLst/>
              </a:prstGeom>
              <a:ln>
                <a:noFill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038859</a:t>
                </a: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8705974" y="3178498"/>
              <a:ext cx="1737360" cy="1283547"/>
              <a:chOff x="8705974" y="3178498"/>
              <a:chExt cx="1737360" cy="1283547"/>
            </a:xfrm>
          </p:grpSpPr>
          <p:sp>
            <p:nvSpPr>
              <p:cNvPr id="23" name="Rectangle 22"/>
              <p:cNvSpPr/>
              <p:nvPr/>
            </p:nvSpPr>
            <p:spPr>
              <a:xfrm>
                <a:off x="8912054" y="4136657"/>
                <a:ext cx="1215804" cy="325388"/>
              </a:xfrm>
              <a:prstGeom prst="rect">
                <a:avLst/>
              </a:prstGeom>
              <a:ln>
                <a:noFill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038312</a:t>
                </a:r>
              </a:p>
            </p:txBody>
          </p:sp>
          <p:pic>
            <p:nvPicPr>
              <p:cNvPr id="24" name="Picture 23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05974" y="3178498"/>
                <a:ext cx="1737360" cy="936553"/>
              </a:xfrm>
              <a:prstGeom prst="rect">
                <a:avLst/>
              </a:prstGeom>
              <a:ln>
                <a:noFill/>
              </a:ln>
            </p:spPr>
          </p:pic>
        </p:grpSp>
        <p:grpSp>
          <p:nvGrpSpPr>
            <p:cNvPr id="19" name="Group 18"/>
            <p:cNvGrpSpPr/>
            <p:nvPr/>
          </p:nvGrpSpPr>
          <p:grpSpPr>
            <a:xfrm>
              <a:off x="8755522" y="4396422"/>
              <a:ext cx="1737360" cy="1134760"/>
              <a:chOff x="8755522" y="4534922"/>
              <a:chExt cx="1737360" cy="1134760"/>
            </a:xfrm>
          </p:grpSpPr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55522" y="4534922"/>
                <a:ext cx="1737360" cy="809372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27" name="Rectangle 26"/>
              <p:cNvSpPr/>
              <p:nvPr/>
            </p:nvSpPr>
            <p:spPr>
              <a:xfrm>
                <a:off x="9118727" y="5344294"/>
                <a:ext cx="1215804" cy="325388"/>
              </a:xfrm>
              <a:prstGeom prst="rect">
                <a:avLst/>
              </a:prstGeom>
              <a:ln>
                <a:noFill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038320</a:t>
                </a:r>
              </a:p>
            </p:txBody>
          </p:sp>
        </p:grpSp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90592" y="5447584"/>
              <a:ext cx="2326153" cy="926572"/>
            </a:xfrm>
            <a:prstGeom prst="rect">
              <a:avLst/>
            </a:prstGeom>
            <a:ln>
              <a:noFill/>
            </a:ln>
          </p:spPr>
        </p:pic>
        <p:sp>
          <p:nvSpPr>
            <p:cNvPr id="30" name="Rectangle 29"/>
            <p:cNvSpPr/>
            <p:nvPr/>
          </p:nvSpPr>
          <p:spPr>
            <a:xfrm>
              <a:off x="9168276" y="6394019"/>
              <a:ext cx="1215804" cy="325388"/>
            </a:xfrm>
            <a:prstGeom prst="rect">
              <a:avLst/>
            </a:prstGeom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200" dirty="0"/>
                <a:t>KU0038174</a:t>
              </a:r>
            </a:p>
          </p:txBody>
        </p:sp>
      </p:grpSp>
      <p:sp>
        <p:nvSpPr>
          <p:cNvPr id="31" name="Rectangle 30"/>
          <p:cNvSpPr/>
          <p:nvPr/>
        </p:nvSpPr>
        <p:spPr>
          <a:xfrm>
            <a:off x="1965848" y="1357176"/>
            <a:ext cx="1361661" cy="18799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254220" y="5053557"/>
            <a:ext cx="61465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emical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uctur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dose-response data and for the compounds found in Cluster 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Figure S1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14710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3434" y="1724053"/>
            <a:ext cx="4621405" cy="245474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0" name="Group 29"/>
          <p:cNvGrpSpPr/>
          <p:nvPr/>
        </p:nvGrpSpPr>
        <p:grpSpPr>
          <a:xfrm>
            <a:off x="7448735" y="5317435"/>
            <a:ext cx="1140726" cy="1331843"/>
            <a:chOff x="561312" y="3207733"/>
            <a:chExt cx="1737360" cy="1689873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1312" y="3207733"/>
              <a:ext cx="1737360" cy="1308556"/>
            </a:xfrm>
            <a:prstGeom prst="rect">
              <a:avLst/>
            </a:prstGeom>
          </p:spPr>
        </p:pic>
        <p:sp>
          <p:nvSpPr>
            <p:cNvPr id="32" name="Rectangle 31"/>
            <p:cNvSpPr/>
            <p:nvPr/>
          </p:nvSpPr>
          <p:spPr>
            <a:xfrm>
              <a:off x="650870" y="4579801"/>
              <a:ext cx="1433370" cy="31780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/>
                <a:t>KU0205161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5695121" y="405330"/>
            <a:ext cx="4750906" cy="4912105"/>
            <a:chOff x="3836092" y="440499"/>
            <a:chExt cx="4923083" cy="5884546"/>
          </a:xfrm>
        </p:grpSpPr>
        <p:grpSp>
          <p:nvGrpSpPr>
            <p:cNvPr id="9" name="Group 8"/>
            <p:cNvGrpSpPr/>
            <p:nvPr/>
          </p:nvGrpSpPr>
          <p:grpSpPr>
            <a:xfrm>
              <a:off x="7456154" y="4589288"/>
              <a:ext cx="1303020" cy="1458508"/>
              <a:chOff x="519953" y="889285"/>
              <a:chExt cx="1737360" cy="1458508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9953" y="889285"/>
                <a:ext cx="1737360" cy="1149426"/>
              </a:xfrm>
              <a:prstGeom prst="rect">
                <a:avLst/>
              </a:prstGeom>
            </p:spPr>
          </p:pic>
          <p:sp>
            <p:nvSpPr>
              <p:cNvPr id="11" name="Rectangle 10"/>
              <p:cNvSpPr/>
              <p:nvPr/>
            </p:nvSpPr>
            <p:spPr>
              <a:xfrm>
                <a:off x="561312" y="2070794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163</a:t>
                </a: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7456155" y="3354046"/>
              <a:ext cx="1303020" cy="1333714"/>
              <a:chOff x="4589954" y="519953"/>
              <a:chExt cx="1737360" cy="1333714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89954" y="519953"/>
                <a:ext cx="1737360" cy="960674"/>
              </a:xfrm>
              <a:prstGeom prst="rect">
                <a:avLst/>
              </a:prstGeom>
            </p:spPr>
          </p:pic>
          <p:sp>
            <p:nvSpPr>
              <p:cNvPr id="14" name="Rectangle 13"/>
              <p:cNvSpPr/>
              <p:nvPr/>
            </p:nvSpPr>
            <p:spPr>
              <a:xfrm>
                <a:off x="4594845" y="1576668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133</a:t>
                </a: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7456153" y="1930080"/>
              <a:ext cx="1303020" cy="1348074"/>
              <a:chOff x="4594845" y="1984206"/>
              <a:chExt cx="1737360" cy="1348074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94845" y="1984206"/>
                <a:ext cx="1737360" cy="1028230"/>
              </a:xfrm>
              <a:prstGeom prst="rect">
                <a:avLst/>
              </a:prstGeom>
            </p:spPr>
          </p:pic>
          <p:sp>
            <p:nvSpPr>
              <p:cNvPr id="17" name="Rectangle 16"/>
              <p:cNvSpPr/>
              <p:nvPr/>
            </p:nvSpPr>
            <p:spPr>
              <a:xfrm>
                <a:off x="4760713" y="3055281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165</a:t>
                </a: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7304576" y="440499"/>
              <a:ext cx="1303020" cy="1465438"/>
              <a:chOff x="4923999" y="4787579"/>
              <a:chExt cx="1737360" cy="1465438"/>
            </a:xfrm>
          </p:grpSpPr>
          <p:pic>
            <p:nvPicPr>
              <p:cNvPr id="19" name="Picture 18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23999" y="4787579"/>
                <a:ext cx="1737360" cy="1188439"/>
              </a:xfrm>
              <a:prstGeom prst="rect">
                <a:avLst/>
              </a:prstGeom>
            </p:spPr>
          </p:pic>
          <p:sp>
            <p:nvSpPr>
              <p:cNvPr id="20" name="Rectangle 19"/>
              <p:cNvSpPr/>
              <p:nvPr/>
            </p:nvSpPr>
            <p:spPr>
              <a:xfrm>
                <a:off x="5121224" y="5976018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089</a:t>
                </a: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5453971" y="2136917"/>
              <a:ext cx="1303020" cy="1364984"/>
              <a:chOff x="1225191" y="308423"/>
              <a:chExt cx="1737360" cy="1364984"/>
            </a:xfrm>
          </p:grpSpPr>
          <p:pic>
            <p:nvPicPr>
              <p:cNvPr id="22" name="Picture 21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25191" y="308423"/>
                <a:ext cx="1737360" cy="1028622"/>
              </a:xfrm>
              <a:prstGeom prst="rect">
                <a:avLst/>
              </a:prstGeom>
            </p:spPr>
          </p:pic>
          <p:sp>
            <p:nvSpPr>
              <p:cNvPr id="23" name="Rectangle 22"/>
              <p:cNvSpPr/>
              <p:nvPr/>
            </p:nvSpPr>
            <p:spPr>
              <a:xfrm>
                <a:off x="1329634" y="1396408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093</a:t>
                </a: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5532304" y="4509912"/>
              <a:ext cx="1303020" cy="1543052"/>
              <a:chOff x="8379968" y="172115"/>
              <a:chExt cx="1737360" cy="1543052"/>
            </a:xfrm>
          </p:grpSpPr>
          <p:pic>
            <p:nvPicPr>
              <p:cNvPr id="25" name="Picture 24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79968" y="172115"/>
                <a:ext cx="1737360" cy="1225695"/>
              </a:xfrm>
              <a:prstGeom prst="rect">
                <a:avLst/>
              </a:prstGeom>
            </p:spPr>
          </p:pic>
          <p:sp>
            <p:nvSpPr>
              <p:cNvPr id="26" name="Rectangle 25"/>
              <p:cNvSpPr/>
              <p:nvPr/>
            </p:nvSpPr>
            <p:spPr>
              <a:xfrm>
                <a:off x="8593075" y="1438168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159</a:t>
                </a:r>
              </a:p>
            </p:txBody>
          </p:sp>
        </p:grpSp>
        <p:grpSp>
          <p:nvGrpSpPr>
            <p:cNvPr id="27" name="Group 26"/>
            <p:cNvGrpSpPr/>
            <p:nvPr/>
          </p:nvGrpSpPr>
          <p:grpSpPr>
            <a:xfrm>
              <a:off x="5453969" y="3196962"/>
              <a:ext cx="1303020" cy="1521323"/>
              <a:chOff x="8378673" y="3054089"/>
              <a:chExt cx="1737360" cy="1521323"/>
            </a:xfrm>
          </p:grpSpPr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78673" y="3054089"/>
                <a:ext cx="1737360" cy="1143546"/>
              </a:xfrm>
              <a:prstGeom prst="rect">
                <a:avLst/>
              </a:prstGeom>
            </p:spPr>
          </p:pic>
          <p:sp>
            <p:nvSpPr>
              <p:cNvPr id="29" name="Rectangle 28"/>
              <p:cNvSpPr/>
              <p:nvPr/>
            </p:nvSpPr>
            <p:spPr>
              <a:xfrm>
                <a:off x="8593076" y="4298413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151</a:t>
                </a:r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3995704" y="4880744"/>
              <a:ext cx="1303020" cy="1444301"/>
              <a:chOff x="7572103" y="308423"/>
              <a:chExt cx="1737360" cy="1444301"/>
            </a:xfrm>
          </p:grpSpPr>
          <p:pic>
            <p:nvPicPr>
              <p:cNvPr id="34" name="Picture 33"/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72103" y="308423"/>
                <a:ext cx="1737360" cy="1098160"/>
              </a:xfrm>
              <a:prstGeom prst="rect">
                <a:avLst/>
              </a:prstGeom>
            </p:spPr>
          </p:pic>
          <p:sp>
            <p:nvSpPr>
              <p:cNvPr id="35" name="Rectangle 34"/>
              <p:cNvSpPr/>
              <p:nvPr/>
            </p:nvSpPr>
            <p:spPr>
              <a:xfrm>
                <a:off x="7779099" y="1475725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099</a:t>
                </a:r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5273709" y="583846"/>
              <a:ext cx="1303020" cy="1410984"/>
              <a:chOff x="1089284" y="2640105"/>
              <a:chExt cx="1737360" cy="1410984"/>
            </a:xfrm>
          </p:grpSpPr>
          <p:pic>
            <p:nvPicPr>
              <p:cNvPr id="37" name="Picture 36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9284" y="2640105"/>
                <a:ext cx="1737360" cy="1029193"/>
              </a:xfrm>
              <a:prstGeom prst="rect">
                <a:avLst/>
              </a:prstGeom>
            </p:spPr>
          </p:pic>
          <p:sp>
            <p:nvSpPr>
              <p:cNvPr id="38" name="Rectangle 37"/>
              <p:cNvSpPr/>
              <p:nvPr/>
            </p:nvSpPr>
            <p:spPr>
              <a:xfrm>
                <a:off x="1329633" y="3774090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087</a:t>
                </a:r>
              </a:p>
            </p:txBody>
          </p:sp>
        </p:grpSp>
        <p:grpSp>
          <p:nvGrpSpPr>
            <p:cNvPr id="39" name="Group 38"/>
            <p:cNvGrpSpPr/>
            <p:nvPr/>
          </p:nvGrpSpPr>
          <p:grpSpPr>
            <a:xfrm>
              <a:off x="3836092" y="3453473"/>
              <a:ext cx="1303020" cy="1438671"/>
              <a:chOff x="8037708" y="3331754"/>
              <a:chExt cx="1737360" cy="1438671"/>
            </a:xfrm>
          </p:grpSpPr>
          <p:pic>
            <p:nvPicPr>
              <p:cNvPr id="40" name="Picture 39"/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7708" y="3331754"/>
                <a:ext cx="1737360" cy="1161672"/>
              </a:xfrm>
              <a:prstGeom prst="rect">
                <a:avLst/>
              </a:prstGeom>
            </p:spPr>
          </p:pic>
          <p:sp>
            <p:nvSpPr>
              <p:cNvPr id="41" name="Rectangle 40"/>
              <p:cNvSpPr/>
              <p:nvPr/>
            </p:nvSpPr>
            <p:spPr>
              <a:xfrm>
                <a:off x="8330589" y="4493426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119</a:t>
                </a:r>
              </a:p>
            </p:txBody>
          </p:sp>
        </p:grpSp>
        <p:grpSp>
          <p:nvGrpSpPr>
            <p:cNvPr id="42" name="Group 41"/>
            <p:cNvGrpSpPr/>
            <p:nvPr/>
          </p:nvGrpSpPr>
          <p:grpSpPr>
            <a:xfrm>
              <a:off x="3836093" y="534429"/>
              <a:ext cx="1303020" cy="1383274"/>
              <a:chOff x="4398050" y="2410006"/>
              <a:chExt cx="1737360" cy="1383274"/>
            </a:xfrm>
          </p:grpSpPr>
          <p:pic>
            <p:nvPicPr>
              <p:cNvPr id="43" name="Picture 42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98050" y="2410006"/>
                <a:ext cx="1737360" cy="1042645"/>
              </a:xfrm>
              <a:prstGeom prst="rect">
                <a:avLst/>
              </a:prstGeom>
            </p:spPr>
          </p:pic>
          <p:sp>
            <p:nvSpPr>
              <p:cNvPr id="44" name="Rectangle 43"/>
              <p:cNvSpPr/>
              <p:nvPr/>
            </p:nvSpPr>
            <p:spPr>
              <a:xfrm>
                <a:off x="4629127" y="3516281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125</a:t>
                </a:r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3897210" y="2020287"/>
              <a:ext cx="1303020" cy="1381690"/>
              <a:chOff x="757125" y="3909511"/>
              <a:chExt cx="1737360" cy="1381690"/>
            </a:xfrm>
          </p:grpSpPr>
          <p:pic>
            <p:nvPicPr>
              <p:cNvPr id="45" name="Picture 44"/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7125" y="3909511"/>
                <a:ext cx="1737360" cy="1063547"/>
              </a:xfrm>
              <a:prstGeom prst="rect">
                <a:avLst/>
              </a:prstGeom>
            </p:spPr>
          </p:pic>
          <p:sp>
            <p:nvSpPr>
              <p:cNvPr id="46" name="Rectangle 45"/>
              <p:cNvSpPr/>
              <p:nvPr/>
            </p:nvSpPr>
            <p:spPr>
              <a:xfrm>
                <a:off x="871570" y="5014202"/>
                <a:ext cx="12158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/>
                  <a:t>KU0205183</a:t>
                </a:r>
              </a:p>
            </p:txBody>
          </p:sp>
        </p:grpSp>
      </p:grpSp>
      <p:sp>
        <p:nvSpPr>
          <p:cNvPr id="3" name="TextBox 2"/>
          <p:cNvSpPr txBox="1"/>
          <p:nvPr/>
        </p:nvSpPr>
        <p:spPr>
          <a:xfrm>
            <a:off x="1685512" y="405330"/>
            <a:ext cx="27277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+mj-lt"/>
                <a:ea typeface="Cambria Math" panose="02040503050406030204" pitchFamily="18" charset="0"/>
              </a:rPr>
              <a:t>Cluster from CNS Library</a:t>
            </a:r>
          </a:p>
        </p:txBody>
      </p:sp>
      <p:sp>
        <p:nvSpPr>
          <p:cNvPr id="5" name="Rectangle 4"/>
          <p:cNvSpPr/>
          <p:nvPr/>
        </p:nvSpPr>
        <p:spPr>
          <a:xfrm>
            <a:off x="1580322" y="1821409"/>
            <a:ext cx="1302026" cy="12666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/>
          <p:cNvSpPr txBox="1"/>
          <p:nvPr/>
        </p:nvSpPr>
        <p:spPr>
          <a:xfrm>
            <a:off x="254221" y="5053557"/>
            <a:ext cx="57447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mical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uctures and dose-response data and for the compounds found in Cluste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Figure S1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11738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617" y="1011051"/>
            <a:ext cx="6147588" cy="5627688"/>
          </a:xfrm>
        </p:spPr>
      </p:pic>
      <p:sp>
        <p:nvSpPr>
          <p:cNvPr id="6" name="TextBox 5"/>
          <p:cNvSpPr txBox="1"/>
          <p:nvPr/>
        </p:nvSpPr>
        <p:spPr>
          <a:xfrm>
            <a:off x="7322032" y="1484876"/>
            <a:ext cx="39500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plot of 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ag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milarity fo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specific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PO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hibitors (183 compounds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mical similarity was calculated using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Warrior</a:t>
            </a:r>
            <a:r>
              <a:rPr lang="en-US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ftware packag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Each compound is labeled with a number corresponding to the data in supplemental file 1.  The markers are colored according to IC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alues and the number of Lipinski violations are indicated by marker shape. 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521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48E3B7FD32D945A6300F12E3E04346" ma:contentTypeVersion="13" ma:contentTypeDescription="Create a new document." ma:contentTypeScope="" ma:versionID="38cd937c42f75382cd58f7c4c9cedb79">
  <xsd:schema xmlns:xsd="http://www.w3.org/2001/XMLSchema" xmlns:xs="http://www.w3.org/2001/XMLSchema" xmlns:p="http://schemas.microsoft.com/office/2006/metadata/properties" xmlns:ns3="1305cf80-9ff4-4708-9047-f9dfc54a2931" xmlns:ns4="e72ceee7-ec4c-4c53-bf11-83c1b7729aea" targetNamespace="http://schemas.microsoft.com/office/2006/metadata/properties" ma:root="true" ma:fieldsID="e4efa5b9e6c5e09c37dd7799d61500b6" ns3:_="" ns4:_="">
    <xsd:import namespace="1305cf80-9ff4-4708-9047-f9dfc54a2931"/>
    <xsd:import namespace="e72ceee7-ec4c-4c53-bf11-83c1b7729ae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305cf80-9ff4-4708-9047-f9dfc54a29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72ceee7-ec4c-4c53-bf11-83c1b7729aea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39BFBCF-B6D4-4624-9859-B73FB8FDFBD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305cf80-9ff4-4708-9047-f9dfc54a2931"/>
    <ds:schemaRef ds:uri="e72ceee7-ec4c-4c53-bf11-83c1b7729ae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40D7444-DDDA-44A2-BE37-D040534AA36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ADEFBB2-58ED-426F-91B6-CA2968572B9C}">
  <ds:schemaRefs>
    <ds:schemaRef ds:uri="http://schemas.microsoft.com/office/infopath/2007/PartnerControls"/>
    <ds:schemaRef ds:uri="http://purl.org/dc/elements/1.1/"/>
    <ds:schemaRef ds:uri="http://schemas.microsoft.com/office/2006/metadata/properties"/>
    <ds:schemaRef ds:uri="e72ceee7-ec4c-4c53-bf11-83c1b7729aea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1305cf80-9ff4-4708-9047-f9dfc54a2931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6</Words>
  <Application>Microsoft Office PowerPoint</Application>
  <PresentationFormat>Widescreen</PresentationFormat>
  <Paragraphs>2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Iowa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lson, Scott W [BBMB]</dc:creator>
  <cp:lastModifiedBy>Nelson, Scott W [BBMB]</cp:lastModifiedBy>
  <cp:revision>2</cp:revision>
  <dcterms:created xsi:type="dcterms:W3CDTF">2022-01-20T16:08:44Z</dcterms:created>
  <dcterms:modified xsi:type="dcterms:W3CDTF">2022-01-20T16:09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48E3B7FD32D945A6300F12E3E04346</vt:lpwstr>
  </property>
</Properties>
</file>